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1" r:id="rId2"/>
  </p:sldIdLst>
  <p:sldSz cx="6400800" cy="8229600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2">
          <p15:clr>
            <a:srgbClr val="A4A3A4"/>
          </p15:clr>
        </p15:guide>
        <p15:guide id="2" pos="201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00"/>
    <a:srgbClr val="8BD5B0"/>
    <a:srgbClr val="00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42" autoAdjust="0"/>
    <p:restoredTop sz="94660"/>
  </p:normalViewPr>
  <p:slideViewPr>
    <p:cSldViewPr snapToGrid="0">
      <p:cViewPr varScale="1">
        <p:scale>
          <a:sx n="83" d="100"/>
          <a:sy n="83" d="100"/>
        </p:scale>
        <p:origin x="4180" y="76"/>
      </p:cViewPr>
      <p:guideLst>
        <p:guide orient="horz" pos="2592"/>
        <p:guide pos="20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346836"/>
            <a:ext cx="5440680" cy="2865120"/>
          </a:xfrm>
        </p:spPr>
        <p:txBody>
          <a:bodyPr anchor="b"/>
          <a:lstStyle>
            <a:lvl1pPr algn="ctr">
              <a:defRPr sz="4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4322446"/>
            <a:ext cx="4800600" cy="1986914"/>
          </a:xfrm>
        </p:spPr>
        <p:txBody>
          <a:bodyPr/>
          <a:lstStyle>
            <a:lvl1pPr marL="0" indent="0" algn="ctr">
              <a:buNone/>
              <a:defRPr sz="1680"/>
            </a:lvl1pPr>
            <a:lvl2pPr marL="320040" indent="0" algn="ctr">
              <a:buNone/>
              <a:defRPr sz="1400"/>
            </a:lvl2pPr>
            <a:lvl3pPr marL="640080" indent="0" algn="ctr">
              <a:buNone/>
              <a:defRPr sz="1260"/>
            </a:lvl3pPr>
            <a:lvl4pPr marL="960120" indent="0" algn="ctr">
              <a:buNone/>
              <a:defRPr sz="1120"/>
            </a:lvl4pPr>
            <a:lvl5pPr marL="1280160" indent="0" algn="ctr">
              <a:buNone/>
              <a:defRPr sz="1120"/>
            </a:lvl5pPr>
            <a:lvl6pPr marL="1600200" indent="0" algn="ctr">
              <a:buNone/>
              <a:defRPr sz="1120"/>
            </a:lvl6pPr>
            <a:lvl7pPr marL="1920240" indent="0" algn="ctr">
              <a:buNone/>
              <a:defRPr sz="1120"/>
            </a:lvl7pPr>
            <a:lvl8pPr marL="2240280" indent="0" algn="ctr">
              <a:buNone/>
              <a:defRPr sz="1120"/>
            </a:lvl8pPr>
            <a:lvl9pPr marL="2560320" indent="0" algn="ctr">
              <a:buNone/>
              <a:defRPr sz="112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693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723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3" y="438150"/>
            <a:ext cx="1380173" cy="697420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438150"/>
            <a:ext cx="4060508" cy="697420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027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599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2" y="2051688"/>
            <a:ext cx="5520690" cy="3423284"/>
          </a:xfrm>
        </p:spPr>
        <p:txBody>
          <a:bodyPr anchor="b"/>
          <a:lstStyle>
            <a:lvl1pPr>
              <a:defRPr sz="4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2" y="5507358"/>
            <a:ext cx="5520690" cy="1800224"/>
          </a:xfrm>
        </p:spPr>
        <p:txBody>
          <a:bodyPr/>
          <a:lstStyle>
            <a:lvl1pPr marL="0" indent="0">
              <a:buNone/>
              <a:defRPr sz="1680">
                <a:solidFill>
                  <a:schemeClr val="tx1"/>
                </a:solidFill>
              </a:defRPr>
            </a:lvl1pPr>
            <a:lvl2pPr marL="3200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400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3pPr>
            <a:lvl4pPr marL="9601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4pPr>
            <a:lvl5pPr marL="128016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5pPr>
            <a:lvl6pPr marL="160020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6pPr>
            <a:lvl7pPr marL="192024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7pPr>
            <a:lvl8pPr marL="22402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8pPr>
            <a:lvl9pPr marL="25603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558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2190750"/>
            <a:ext cx="2720340" cy="52216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2190750"/>
            <a:ext cx="2720340" cy="52216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524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38152"/>
            <a:ext cx="5520690" cy="159067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2017396"/>
            <a:ext cx="2707838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3006090"/>
            <a:ext cx="2707838" cy="44215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2017396"/>
            <a:ext cx="2721174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3006090"/>
            <a:ext cx="2721174" cy="44215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571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847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94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1184912"/>
            <a:ext cx="3240405" cy="5848350"/>
          </a:xfrm>
        </p:spPr>
        <p:txBody>
          <a:bodyPr/>
          <a:lstStyle>
            <a:lvl1pPr>
              <a:defRPr sz="2240"/>
            </a:lvl1pPr>
            <a:lvl2pPr>
              <a:defRPr sz="1960"/>
            </a:lvl2pPr>
            <a:lvl3pPr>
              <a:defRPr sz="168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231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1184912"/>
            <a:ext cx="3240405" cy="5848350"/>
          </a:xfrm>
        </p:spPr>
        <p:txBody>
          <a:bodyPr anchor="t"/>
          <a:lstStyle>
            <a:lvl1pPr marL="0" indent="0">
              <a:buNone/>
              <a:defRPr sz="2240"/>
            </a:lvl1pPr>
            <a:lvl2pPr marL="320040" indent="0">
              <a:buNone/>
              <a:defRPr sz="1960"/>
            </a:lvl2pPr>
            <a:lvl3pPr marL="640080" indent="0">
              <a:buNone/>
              <a:defRPr sz="1680"/>
            </a:lvl3pPr>
            <a:lvl4pPr marL="960120" indent="0">
              <a:buNone/>
              <a:defRPr sz="1400"/>
            </a:lvl4pPr>
            <a:lvl5pPr marL="1280160" indent="0">
              <a:buNone/>
              <a:defRPr sz="1400"/>
            </a:lvl5pPr>
            <a:lvl6pPr marL="1600200" indent="0">
              <a:buNone/>
              <a:defRPr sz="1400"/>
            </a:lvl6pPr>
            <a:lvl7pPr marL="1920240" indent="0">
              <a:buNone/>
              <a:defRPr sz="1400"/>
            </a:lvl7pPr>
            <a:lvl8pPr marL="2240280" indent="0">
              <a:buNone/>
              <a:defRPr sz="1400"/>
            </a:lvl8pPr>
            <a:lvl9pPr marL="2560320" indent="0">
              <a:buNone/>
              <a:defRPr sz="14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870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438152"/>
            <a:ext cx="552069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2190750"/>
            <a:ext cx="552069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7627622"/>
            <a:ext cx="216027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07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0080" rtl="0" eaLnBrk="1" latinLnBrk="0" hangingPunct="1">
        <a:lnSpc>
          <a:spcPct val="90000"/>
        </a:lnSpc>
        <a:spcBef>
          <a:spcPct val="0"/>
        </a:spcBef>
        <a:buNone/>
        <a:defRPr sz="3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020" indent="-160020" algn="l" defTabSz="64008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001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201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76022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20802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7203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1pPr>
      <a:lvl2pPr marL="3200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400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60020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2402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5603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2707826" y="592531"/>
            <a:ext cx="3706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39874" y="595314"/>
            <a:ext cx="3706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8943" y="860490"/>
            <a:ext cx="951336" cy="2854008"/>
          </a:xfrm>
          <a:prstGeom prst="rect">
            <a:avLst/>
          </a:prstGeom>
        </p:spPr>
      </p:pic>
      <p:cxnSp>
        <p:nvCxnSpPr>
          <p:cNvPr id="20" name="Straight Connector 19"/>
          <p:cNvCxnSpPr/>
          <p:nvPr/>
        </p:nvCxnSpPr>
        <p:spPr>
          <a:xfrm rot="60000">
            <a:off x="2030399" y="2902915"/>
            <a:ext cx="0" cy="457200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2029730" y="927811"/>
            <a:ext cx="0" cy="365760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1977576" y="2983565"/>
            <a:ext cx="7120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Arial" pitchFamily="34" charset="0"/>
                <a:cs typeface="Arial" pitchFamily="34" charset="0"/>
              </a:rPr>
              <a:t>gb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 down</a:t>
            </a:r>
          </a:p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1115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976562" y="897331"/>
            <a:ext cx="5341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err="1">
                <a:latin typeface="Arial" pitchFamily="34" charset="0"/>
                <a:cs typeface="Arial" pitchFamily="34" charset="0"/>
              </a:rPr>
              <a:t>gb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 up</a:t>
            </a:r>
          </a:p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892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906163" y="677720"/>
            <a:ext cx="13821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lymerase density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2862061" y="804833"/>
            <a:ext cx="2487366" cy="2834958"/>
            <a:chOff x="2760461" y="1010588"/>
            <a:chExt cx="2487366" cy="2834958"/>
          </a:xfrm>
        </p:grpSpPr>
        <p:pic>
          <p:nvPicPr>
            <p:cNvPr id="4" name="Picture 3" descr="enplot_P17UPFC2_13.png"/>
            <p:cNvPicPr>
              <a:picLocks noChangeAspect="1"/>
            </p:cNvPicPr>
            <p:nvPr/>
          </p:nvPicPr>
          <p:blipFill rotWithShape="1">
            <a:blip r:embed="rId3" cstate="print"/>
            <a:srcRect b="44588"/>
            <a:stretch/>
          </p:blipFill>
          <p:spPr>
            <a:xfrm>
              <a:off x="3078835" y="1293058"/>
              <a:ext cx="1981200" cy="990600"/>
            </a:xfrm>
            <a:prstGeom prst="rect">
              <a:avLst/>
            </a:prstGeom>
          </p:spPr>
        </p:pic>
        <p:pic>
          <p:nvPicPr>
            <p:cNvPr id="5" name="Picture 4" descr="enplot_P17DOWNFC2_15.png"/>
            <p:cNvPicPr>
              <a:picLocks noChangeAspect="1"/>
            </p:cNvPicPr>
            <p:nvPr/>
          </p:nvPicPr>
          <p:blipFill rotWithShape="1">
            <a:blip r:embed="rId4" cstate="print"/>
            <a:srcRect b="44273"/>
            <a:stretch/>
          </p:blipFill>
          <p:spPr>
            <a:xfrm>
              <a:off x="3095178" y="2779541"/>
              <a:ext cx="2057399" cy="997903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 rot="10800000">
              <a:off x="2862648" y="2069008"/>
              <a:ext cx="307777" cy="30480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 0.2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 rot="10800000">
              <a:off x="2862649" y="1760043"/>
              <a:ext cx="307777" cy="150041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 rot="10800000">
              <a:off x="2862649" y="1178892"/>
              <a:ext cx="307777" cy="294311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.35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 rot="10800000">
              <a:off x="2878988" y="3524690"/>
              <a:ext cx="307777" cy="32085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 0.7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0800000">
              <a:off x="2878990" y="3228099"/>
              <a:ext cx="307777" cy="27026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0.4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0800000">
              <a:off x="2878990" y="2748029"/>
              <a:ext cx="307777" cy="150041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008747" y="1010588"/>
              <a:ext cx="210506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gene body up regulated, P17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947196" y="2504372"/>
              <a:ext cx="230063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gene body down regulated, P17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116175" y="1353368"/>
              <a:ext cx="71526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ES = 1.57</a:t>
              </a:r>
            </a:p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DR = 0.0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159883" y="2866262"/>
              <a:ext cx="74892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ES = -2.65</a:t>
              </a:r>
            </a:p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DR = 0.0</a:t>
              </a:r>
            </a:p>
          </p:txBody>
        </p:sp>
        <p:cxnSp>
          <p:nvCxnSpPr>
            <p:cNvPr id="17" name="Straight Connector 16"/>
            <p:cNvCxnSpPr/>
            <p:nvPr/>
          </p:nvCxnSpPr>
          <p:spPr>
            <a:xfrm flipH="1">
              <a:off x="3084933" y="2805274"/>
              <a:ext cx="1" cy="86868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/>
            <p:cNvSpPr txBox="1"/>
            <p:nvPr/>
          </p:nvSpPr>
          <p:spPr>
            <a:xfrm rot="16200000">
              <a:off x="2338625" y="1622906"/>
              <a:ext cx="10591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nrichment Score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 rot="16200000">
              <a:off x="2338625" y="3140164"/>
              <a:ext cx="10591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nrichment Score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" name="Rectangle 25"/>
          <p:cNvSpPr/>
          <p:nvPr/>
        </p:nvSpPr>
        <p:spPr>
          <a:xfrm>
            <a:off x="1364047" y="4036270"/>
            <a:ext cx="356898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gb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up: up-regulated in gene body </a:t>
            </a:r>
            <a:r>
              <a:rPr lang="en-US" sz="1200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regions</a:t>
            </a:r>
          </a:p>
          <a:p>
            <a:r>
              <a:rPr lang="en-US" sz="1200" dirty="0" err="1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gb</a:t>
            </a:r>
            <a:r>
              <a:rPr lang="en-US" sz="1200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own: down-regulated in gene body region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4567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07</TotalTime>
  <Words>64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SimSun</vt:lpstr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Jing</dc:creator>
  <cp:lastModifiedBy>Wang, Jing</cp:lastModifiedBy>
  <cp:revision>139</cp:revision>
  <cp:lastPrinted>2016-09-27T21:35:30Z</cp:lastPrinted>
  <dcterms:created xsi:type="dcterms:W3CDTF">2016-09-06T21:27:57Z</dcterms:created>
  <dcterms:modified xsi:type="dcterms:W3CDTF">2018-07-10T22:01:14Z</dcterms:modified>
</cp:coreProperties>
</file>